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ct" ContentType="image/x-pict"/>
  <Override PartName="/ppt/media/image2.pct" ContentType="image/x-pict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FB2E3F-525B-42BF-87F5-CF5AB3BB540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4C0C9B-8E25-4BC6-9925-81E1A3EF9C4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3EF198-B482-4CBD-B9E5-5EF199E8D2E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09BC35-29B2-454E-AC11-1B4E8285595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05F4AC-CE77-4FF2-B7FB-A71F53D9F56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890F6F-87F9-4FE4-94A9-342C66104A5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085B93-5126-4ED9-83FB-5EC32D2E5C6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136C68-E0CF-4871-8E3A-521C308D16D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F280B0-89F2-4768-9FA1-2AD1B2D0CA3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E28814-DCBB-4ABD-8C90-519D9EDCA0F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BEDF51-750F-4D8B-A2A8-E7943277EFD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33DE59-641F-4F35-A555-29A8431F57E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7A5C842-0916-4DEA-8B2F-70FCC0184DE5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ct"/><Relationship Id="rId2" Type="http://schemas.openxmlformats.org/officeDocument/2006/relationships/image" Target="../media/image2.pct"/><Relationship Id="rId3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5040" y="44280"/>
            <a:ext cx="2183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upplement Figure 3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4818600" y="471600"/>
            <a:ext cx="43668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154440" y="471600"/>
            <a:ext cx="43668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4" name="" descr=""/>
          <p:cNvPicPr/>
          <p:nvPr/>
        </p:nvPicPr>
        <p:blipFill>
          <a:blip r:embed="rId1"/>
          <a:stretch/>
        </p:blipFill>
        <p:spPr>
          <a:xfrm>
            <a:off x="0" y="1528920"/>
            <a:ext cx="5105520" cy="3690720"/>
          </a:xfrm>
          <a:prstGeom prst="rect">
            <a:avLst/>
          </a:prstGeom>
          <a:ln w="0">
            <a:noFill/>
          </a:ln>
        </p:spPr>
      </p:pic>
      <p:pic>
        <p:nvPicPr>
          <p:cNvPr id="45" name="" descr=""/>
          <p:cNvPicPr/>
          <p:nvPr/>
        </p:nvPicPr>
        <p:blipFill>
          <a:blip r:embed="rId2"/>
          <a:stretch/>
        </p:blipFill>
        <p:spPr>
          <a:xfrm>
            <a:off x="4952880" y="1528920"/>
            <a:ext cx="4038840" cy="3957480"/>
          </a:xfrm>
          <a:prstGeom prst="rect">
            <a:avLst/>
          </a:prstGeom>
          <a:ln w="0">
            <a:noFill/>
          </a:ln>
        </p:spPr>
      </p:pic>
      <p:sp>
        <p:nvSpPr>
          <p:cNvPr id="46" name=""/>
          <p:cNvSpPr/>
          <p:nvPr/>
        </p:nvSpPr>
        <p:spPr>
          <a:xfrm>
            <a:off x="150120" y="990720"/>
            <a:ext cx="30762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BioCarta Pathways: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omparison of enrichment levels of all lis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5179320" y="990720"/>
            <a:ext cx="30762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KEGG Pathways: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omparison of enrichment levels of all lis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2-19T04:04:12Z</dcterms:created>
  <dc:creator>Kai Sonntag</dc:creator>
  <dc:description/>
  <dc:language>en-US</dc:language>
  <cp:lastModifiedBy>Kai Sonntag</cp:lastModifiedBy>
  <dcterms:modified xsi:type="dcterms:W3CDTF">2009-08-28T00:05:40Z</dcterms:modified>
  <cp:revision>20</cp:revision>
  <dc:subject/>
  <dc:title>PowerPoint Presentation</dc:title>
</cp:coreProperties>
</file>